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80" d="100"/>
          <a:sy n="80" d="100"/>
        </p:scale>
        <p:origin x="136" y="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E3A0F9-9661-431B-B658-5D4A7ADE352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1FBFD3E-2248-4F35-9308-386DF2033EE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1EE51C-BE98-4CD7-A992-A7D1B9918D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857D-3AD2-47C8-BDF4-51E87FFDB7DA}" type="datetimeFigureOut">
              <a:rPr lang="en-GB" smtClean="0"/>
              <a:t>29/10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4666D2-692C-428E-A2BD-8519AA290E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841E57-4D45-4CDC-9877-7E698328A7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1E0CB-6826-4B9A-BCB4-BE8BCC8FED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40204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A9C742-13DE-46BA-9666-3B4CEAF81F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AFC86B6-7741-4BC9-AEAE-1A2662FE5A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530115-DD4D-4585-9C58-3512D038D5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857D-3AD2-47C8-BDF4-51E87FFDB7DA}" type="datetimeFigureOut">
              <a:rPr lang="en-GB" smtClean="0"/>
              <a:t>29/10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FA78B9-1E7C-40EB-A6B7-7A62C82339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C135F2-92C4-4A1D-A280-3A9D9F9D07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1E0CB-6826-4B9A-BCB4-BE8BCC8FED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96844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F9F8109-B4AC-4099-9215-5C33C6562A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CAAE91E-F041-4435-8D2C-5CB27C67E5A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DBE930-44BD-489E-929C-856692AA4F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857D-3AD2-47C8-BDF4-51E87FFDB7DA}" type="datetimeFigureOut">
              <a:rPr lang="en-GB" smtClean="0"/>
              <a:t>29/10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81A29B-C72C-4E3A-AFB7-5AE1857489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F841E6-5701-409E-9057-1F90118A73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1E0CB-6826-4B9A-BCB4-BE8BCC8FED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17143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9B8BF9-CCC5-4B83-8DC9-F95771C5D5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7BFE91-13B9-4FCF-A904-6ABA2C110A0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8A24B7-853D-46A4-9C8B-7452F6B13A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857D-3AD2-47C8-BDF4-51E87FFDB7DA}" type="datetimeFigureOut">
              <a:rPr lang="en-GB" smtClean="0"/>
              <a:t>29/10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2CCC0F-5A77-4A0B-A857-B54E9EE578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C756FF-F38E-49C3-A04A-83336F8289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1E0CB-6826-4B9A-BCB4-BE8BCC8FED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87708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5D7952-8E77-43B1-8B8D-9849446BFF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E3A8F9A-84C7-4FEA-AC65-A2C23336FF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57B71E-78D7-458E-AB14-29CE439E39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857D-3AD2-47C8-BDF4-51E87FFDB7DA}" type="datetimeFigureOut">
              <a:rPr lang="en-GB" smtClean="0"/>
              <a:t>29/10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C7335E-51B7-4708-AEF3-FAB4AC34FF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3DDF5B-004E-43C9-9003-FB8A6D4486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1E0CB-6826-4B9A-BCB4-BE8BCC8FED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30909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942F39-079B-4DB6-A7B1-DC6F93A924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F8FE0A-29CB-4419-95C3-7D81FBE83D2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7F2F338-BC8E-4D48-8211-2107C1F917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EB09C5-C6C6-4918-956A-F9347BB038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857D-3AD2-47C8-BDF4-51E87FFDB7DA}" type="datetimeFigureOut">
              <a:rPr lang="en-GB" smtClean="0"/>
              <a:t>29/10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9A6F1EF-6AA6-443D-81FD-696B8A6E10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CC8EA6C-02C9-4BFC-92BF-2B8EA26403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1E0CB-6826-4B9A-BCB4-BE8BCC8FED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73798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61FE28-6ACC-45A3-992E-D9C54368F3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BF9819C-525E-4ED4-A34B-8AD863D6F0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1E45B72-F4E5-43D6-B3CC-51DB74220E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C3E020C-CC60-4A11-B90B-FB9E107684E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2FDABFC-BAB3-4607-BF98-EAFF436DE6C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1823E02-FAF2-44D3-B1BA-21600CC0E8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857D-3AD2-47C8-BDF4-51E87FFDB7DA}" type="datetimeFigureOut">
              <a:rPr lang="en-GB" smtClean="0"/>
              <a:t>29/10/2020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FDB1704-7479-4F54-8F63-98AA50BD30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F659F9E-17BB-496A-8959-8912ECDCEF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1E0CB-6826-4B9A-BCB4-BE8BCC8FED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65897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A5509C-4593-42E6-9AA6-EB1A05862D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97D3093-2CDB-4ABF-8E08-A111117B81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857D-3AD2-47C8-BDF4-51E87FFDB7DA}" type="datetimeFigureOut">
              <a:rPr lang="en-GB" smtClean="0"/>
              <a:t>29/10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33266BF-FEB6-4B4C-9A3C-0A4B9DC052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28D077A-6C26-412B-84B6-8AD44D4CD2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1E0CB-6826-4B9A-BCB4-BE8BCC8FED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21514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44E8FB1-7B16-4E95-852D-347AD6C054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857D-3AD2-47C8-BDF4-51E87FFDB7DA}" type="datetimeFigureOut">
              <a:rPr lang="en-GB" smtClean="0"/>
              <a:t>29/10/2020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6B61440-8A71-46A3-9300-3D4A318E62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BBB4591-3842-49CB-A50F-AC5220C937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1E0CB-6826-4B9A-BCB4-BE8BCC8FED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55958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C6BFC0-9F5B-47CE-B76A-3D4695F810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F6D6F6D-7329-4CAC-B49E-59B895D501E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44F7F0B-CE10-4EB0-84D4-BC9F618897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4BEC2B-B798-48AD-8B49-256BBF86C2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857D-3AD2-47C8-BDF4-51E87FFDB7DA}" type="datetimeFigureOut">
              <a:rPr lang="en-GB" smtClean="0"/>
              <a:t>29/10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8D895F4-C4C5-4F4A-AB71-3390313DF8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D2A39CE-2EC7-4441-A148-690BC6F260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1E0CB-6826-4B9A-BCB4-BE8BCC8FED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58270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693AAA-EDFD-439F-B6CE-839DC077A2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40E8E32-2AD7-48C1-8258-46FAB9BE68C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9652954-62A4-4923-9A8C-F05D5F5321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7F46BC-4488-4BD2-84B7-65E2A51D01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B857D-3AD2-47C8-BDF4-51E87FFDB7DA}" type="datetimeFigureOut">
              <a:rPr lang="en-GB" smtClean="0"/>
              <a:t>29/10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D03920E-C511-42CC-959F-59E7BE9473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A9C96F2-4F0F-48EC-B00E-04696991B7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1E0CB-6826-4B9A-BCB4-BE8BCC8FED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41903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97837C2-152B-498F-A27A-A053671AD2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FE5F97-B659-40A7-A3E0-79FC1E941F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D1B8BD-15CE-4B6C-B2AB-DD426E50C8F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DB857D-3AD2-47C8-BDF4-51E87FFDB7DA}" type="datetimeFigureOut">
              <a:rPr lang="en-GB" smtClean="0"/>
              <a:t>29/10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5FF530-1C6A-46BB-B22F-607585209F8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B5F115-1F80-4A80-9BC2-318562D9464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51E0CB-6826-4B9A-BCB4-BE8BCC8FED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12277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EDE1DF20-55AA-4236-9151-43D678BEA09E}"/>
              </a:ext>
            </a:extLst>
          </p:cNvPr>
          <p:cNvGrpSpPr/>
          <p:nvPr/>
        </p:nvGrpSpPr>
        <p:grpSpPr>
          <a:xfrm>
            <a:off x="2200275" y="892971"/>
            <a:ext cx="1676400" cy="3352800"/>
            <a:chOff x="0" y="457200"/>
            <a:chExt cx="1676400" cy="3352800"/>
          </a:xfrm>
        </p:grpSpPr>
        <p:pic>
          <p:nvPicPr>
            <p:cNvPr id="1028" name="Picture 1">
              <a:extLst>
                <a:ext uri="{FF2B5EF4-FFF2-40B4-BE49-F238E27FC236}">
                  <a16:creationId xmlns:a16="http://schemas.microsoft.com/office/drawing/2014/main" id="{2C6441DB-A1B0-4754-AF6E-48430FA072D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457200"/>
              <a:ext cx="1676400" cy="16764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7" name="Picture 21">
              <a:extLst>
                <a:ext uri="{FF2B5EF4-FFF2-40B4-BE49-F238E27FC236}">
                  <a16:creationId xmlns:a16="http://schemas.microsoft.com/office/drawing/2014/main" id="{61C7CDD6-FA0D-4929-BACB-CA409317DB9A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2133600"/>
              <a:ext cx="1676400" cy="16764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1A3500EB-D115-488F-81C9-695407F2BB94}"/>
              </a:ext>
            </a:extLst>
          </p:cNvPr>
          <p:cNvGrpSpPr/>
          <p:nvPr/>
        </p:nvGrpSpPr>
        <p:grpSpPr>
          <a:xfrm>
            <a:off x="5498465" y="892971"/>
            <a:ext cx="1676400" cy="3352800"/>
            <a:chOff x="4023360" y="477520"/>
            <a:chExt cx="1676400" cy="3352800"/>
          </a:xfrm>
        </p:grpSpPr>
        <p:pic>
          <p:nvPicPr>
            <p:cNvPr id="1026" name="Picture 22">
              <a:extLst>
                <a:ext uri="{FF2B5EF4-FFF2-40B4-BE49-F238E27FC236}">
                  <a16:creationId xmlns:a16="http://schemas.microsoft.com/office/drawing/2014/main" id="{FAF91B14-A390-43D4-8D3A-0B5CD34C605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23360" y="477520"/>
              <a:ext cx="1676400" cy="16764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5" name="Picture 23">
              <a:extLst>
                <a:ext uri="{FF2B5EF4-FFF2-40B4-BE49-F238E27FC236}">
                  <a16:creationId xmlns:a16="http://schemas.microsoft.com/office/drawing/2014/main" id="{03217CA7-AB5B-427F-BD2A-35A4EB30B67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23360" y="2153920"/>
              <a:ext cx="1676400" cy="16764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4" name="Rectangle 5">
            <a:extLst>
              <a:ext uri="{FF2B5EF4-FFF2-40B4-BE49-F238E27FC236}">
                <a16:creationId xmlns:a16="http://schemas.microsoft.com/office/drawing/2014/main" id="{F678505A-63A3-4908-A8DF-74116D14DA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8109" y="138498"/>
            <a:ext cx="2535335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upplementary figure 5 </a:t>
            </a:r>
            <a:endParaRPr kumimoji="0" lang="en-GB" altLang="en-US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id="{100E3596-F32A-4CDB-85CC-3B4D090EBC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34708" y="4470013"/>
            <a:ext cx="3131489" cy="9233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200" b="1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Fig</a:t>
            </a:r>
            <a:r>
              <a:rPr kumimoji="0" lang="en-GB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5A: 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ells profile SSC v FSC and gate application (black box) of unstained NS0 cells (</a:t>
            </a:r>
            <a:r>
              <a:rPr lang="en-GB" alt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upper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) and NS0 cells expressing </a:t>
            </a:r>
            <a:r>
              <a:rPr kumimoji="0" lang="en-GB" altLang="en-US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gB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-NT (</a:t>
            </a:r>
            <a:r>
              <a:rPr lang="en-GB" alt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lower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).</a:t>
            </a:r>
            <a:endParaRPr kumimoji="0" lang="en-GB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6" name="Rectangle 7">
            <a:extLst>
              <a:ext uri="{FF2B5EF4-FFF2-40B4-BE49-F238E27FC236}">
                <a16:creationId xmlns:a16="http://schemas.microsoft.com/office/drawing/2014/main" id="{B53B0445-4D4D-4FE0-80FA-1CAFA16AE7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78118" y="4377680"/>
            <a:ext cx="3993493" cy="13849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200" b="1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Fig</a:t>
            </a:r>
            <a:r>
              <a:rPr kumimoji="0" lang="en-GB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5B: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Cell surface expression of </a:t>
            </a:r>
            <a:r>
              <a:rPr kumimoji="0" lang="en-GB" altLang="en-US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gB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-NT.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Binding of human recombinant monoclonal antibody 8F9 IgG to parental NS0 cells (</a:t>
            </a:r>
            <a:r>
              <a:rPr lang="en-GB" alt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upper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) and NS0 cells expressing </a:t>
            </a:r>
            <a:r>
              <a:rPr kumimoji="0" lang="en-GB" altLang="en-US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gB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-NT (</a:t>
            </a:r>
            <a:r>
              <a:rPr lang="en-GB" alt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lower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). Black line represents unstained cells, red represents fluorescence of cells stained with secondary Ab alone (</a:t>
            </a:r>
            <a:r>
              <a:rPr kumimoji="0" lang="en-GB" altLang="en-US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nti-human kappa FITC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) and blue represents cells stained with 8F9 IgG and secondary Ab. </a:t>
            </a:r>
            <a:endParaRPr kumimoji="0" lang="en-GB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33192062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</TotalTime>
  <Words>98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ry Mclean</dc:creator>
  <cp:lastModifiedBy>Gary Mclean</cp:lastModifiedBy>
  <cp:revision>4</cp:revision>
  <dcterms:created xsi:type="dcterms:W3CDTF">2020-07-30T08:41:53Z</dcterms:created>
  <dcterms:modified xsi:type="dcterms:W3CDTF">2020-10-29T15:48:42Z</dcterms:modified>
</cp:coreProperties>
</file>